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315200" cy="96012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72" y="12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798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1867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5928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6728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18800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5504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1972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9642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48551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3650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665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A5089-7C49-4321-85D7-BF11D4ECCD35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4F537-1A0D-4161-A1F9-3EED6091ECE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166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microsoft.com/office/2007/relationships/hdphoto" Target="../media/hdphoto4.wdp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12" Type="http://schemas.openxmlformats.org/officeDocument/2006/relationships/image" Target="../media/image8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microsoft.com/office/2007/relationships/hdphoto" Target="../media/hdphoto3.wdp"/><Relationship Id="rId5" Type="http://schemas.openxmlformats.org/officeDocument/2006/relationships/image" Target="../media/image4.png"/><Relationship Id="rId10" Type="http://schemas.openxmlformats.org/officeDocument/2006/relationships/image" Target="../media/image7.jpeg"/><Relationship Id="rId4" Type="http://schemas.openxmlformats.org/officeDocument/2006/relationships/image" Target="../media/image3.png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04" b="5133"/>
          <a:stretch/>
        </p:blipFill>
        <p:spPr bwMode="auto">
          <a:xfrm>
            <a:off x="4626698" y="4746557"/>
            <a:ext cx="1784611" cy="12995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08" b="6230"/>
          <a:stretch/>
        </p:blipFill>
        <p:spPr bwMode="auto">
          <a:xfrm>
            <a:off x="4626698" y="3513225"/>
            <a:ext cx="1784611" cy="1233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78" b="4352"/>
          <a:stretch/>
        </p:blipFill>
        <p:spPr bwMode="auto">
          <a:xfrm>
            <a:off x="4626698" y="6154579"/>
            <a:ext cx="1784611" cy="1298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19" b="4937"/>
          <a:stretch/>
        </p:blipFill>
        <p:spPr bwMode="auto">
          <a:xfrm>
            <a:off x="4626698" y="2065320"/>
            <a:ext cx="1784611" cy="1302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504" y="6197216"/>
            <a:ext cx="3606614" cy="107397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506" y="2142235"/>
            <a:ext cx="3606616" cy="10644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504" y="3525797"/>
            <a:ext cx="3606619" cy="100539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508" y="4829484"/>
            <a:ext cx="3606615" cy="108283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52736" y="1835696"/>
            <a:ext cx="4193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err="1" smtClean="0">
                <a:latin typeface="Arial" pitchFamily="34" charset="0"/>
                <a:cs typeface="Arial" pitchFamily="34" charset="0"/>
              </a:rPr>
              <a:t>Nifedipine</a:t>
            </a:r>
            <a:r>
              <a:rPr lang="en-CA" sz="1600" dirty="0" smtClean="0">
                <a:latin typeface="Arial" pitchFamily="34" charset="0"/>
                <a:cs typeface="Arial" pitchFamily="34" charset="0"/>
              </a:rPr>
              <a:t> – L-type calcium channel inhibitor</a:t>
            </a:r>
            <a:endParaRPr lang="en-CA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52736" y="3232149"/>
            <a:ext cx="41952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" pitchFamily="34" charset="0"/>
                <a:cs typeface="Arial" pitchFamily="34" charset="0"/>
              </a:rPr>
              <a:t>Verapamil – L-type calcium channel inhibitor</a:t>
            </a:r>
            <a:endParaRPr lang="en-CA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52736" y="4537438"/>
            <a:ext cx="39623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err="1" smtClean="0">
                <a:latin typeface="Arial" pitchFamily="34" charset="0"/>
                <a:cs typeface="Arial" pitchFamily="34" charset="0"/>
              </a:rPr>
              <a:t>Bepridil</a:t>
            </a:r>
            <a:r>
              <a:rPr lang="en-CA" sz="1600" dirty="0" smtClean="0">
                <a:latin typeface="Arial" pitchFamily="34" charset="0"/>
                <a:cs typeface="Arial" pitchFamily="34" charset="0"/>
              </a:rPr>
              <a:t> – T-type calcium channel inhibitor</a:t>
            </a:r>
            <a:endParaRPr lang="en-CA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52736" y="5943516"/>
            <a:ext cx="42267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err="1" smtClean="0">
                <a:latin typeface="Arial" pitchFamily="34" charset="0"/>
                <a:cs typeface="Arial" pitchFamily="34" charset="0"/>
              </a:rPr>
              <a:t>Mibefradil</a:t>
            </a:r>
            <a:r>
              <a:rPr lang="en-CA" sz="1600" dirty="0" smtClean="0">
                <a:latin typeface="Arial" pitchFamily="34" charset="0"/>
                <a:cs typeface="Arial" pitchFamily="34" charset="0"/>
              </a:rPr>
              <a:t>  – T-type calcium channel inhibitor</a:t>
            </a:r>
            <a:endParaRPr lang="en-CA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6672" y="2271431"/>
            <a:ext cx="805767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Thomas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4394" y="2845014"/>
            <a:ext cx="638045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Sham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6672" y="4989176"/>
            <a:ext cx="805767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Thomas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4394" y="5562759"/>
            <a:ext cx="638045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Sham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76672" y="6314484"/>
            <a:ext cx="805767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Thomas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44394" y="6888067"/>
            <a:ext cx="638045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Sham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6672" y="3596738"/>
            <a:ext cx="805767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Thomas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44394" y="4170321"/>
            <a:ext cx="638045" cy="2904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Sham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21713" y="7271188"/>
            <a:ext cx="3767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Background     1 min       15 min       30 min      45 min      60 min</a:t>
            </a:r>
            <a:endParaRPr lang="en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196902" y="4521430"/>
            <a:ext cx="21435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" pitchFamily="34" charset="0"/>
                <a:cs typeface="Arial" pitchFamily="34" charset="0"/>
              </a:rPr>
              <a:t>Relative fluorescence</a:t>
            </a:r>
            <a:endParaRPr lang="en-CA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3484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6.0&quot;&gt;&lt;object type=&quot;1&quot; unique_id=&quot;10001&quot;&gt;&lt;object type=&quot;8&quot; unique_id=&quot;10020&quot;&gt;&lt;/object&gt;&lt;object type=&quot;2&quot; unique_id=&quot;10021&quot;&gt;&lt;object type=&quot;3&quot; unique_id=&quot;10026&quot;&gt;&lt;property id=&quot;20148&quot; value=&quot;5&quot;/&gt;&lt;property id=&quot;20300&quot; value=&quot;Slide 1&quot;/&gt;&lt;property id=&quot;20307&quot; value=&quot;257&quot;/&gt;&lt;/object&gt;&lt;/object&gt;&lt;/object&gt;&lt;/database&gt;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4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alth Sciences North - Horizon Santé-N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lafrenie</dc:creator>
  <cp:lastModifiedBy>rlafrenie</cp:lastModifiedBy>
  <cp:revision>34</cp:revision>
  <cp:lastPrinted>2015-02-27T16:18:36Z</cp:lastPrinted>
  <dcterms:created xsi:type="dcterms:W3CDTF">2012-11-25T22:31:52Z</dcterms:created>
  <dcterms:modified xsi:type="dcterms:W3CDTF">2015-02-27T16:18:53Z</dcterms:modified>
</cp:coreProperties>
</file>